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30" d="100"/>
          <a:sy n="130" d="100"/>
        </p:scale>
        <p:origin x="82" y="-149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90B-33D8-412A-9759-92A557D10691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5D06F-FC01-4F38-B352-874588A24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700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90B-33D8-412A-9759-92A557D10691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5D06F-FC01-4F38-B352-874588A24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662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90B-33D8-412A-9759-92A557D10691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5D06F-FC01-4F38-B352-874588A24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737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90B-33D8-412A-9759-92A557D10691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5D06F-FC01-4F38-B352-874588A24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3321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90B-33D8-412A-9759-92A557D10691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5D06F-FC01-4F38-B352-874588A24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222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90B-33D8-412A-9759-92A557D10691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5D06F-FC01-4F38-B352-874588A24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978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90B-33D8-412A-9759-92A557D10691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5D06F-FC01-4F38-B352-874588A24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90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90B-33D8-412A-9759-92A557D10691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5D06F-FC01-4F38-B352-874588A24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7997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90B-33D8-412A-9759-92A557D10691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5D06F-FC01-4F38-B352-874588A24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926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90B-33D8-412A-9759-92A557D10691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5D06F-FC01-4F38-B352-874588A24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110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90B-33D8-412A-9759-92A557D10691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5D06F-FC01-4F38-B352-874588A24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922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5F90B-33D8-412A-9759-92A557D10691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05D06F-FC01-4F38-B352-874588A24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3300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228600"/>
            <a:ext cx="8531225" cy="5486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5325" y="232447"/>
            <a:ext cx="1676400" cy="36941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" name="Straight Arrow Connector 4"/>
          <p:cNvCxnSpPr/>
          <p:nvPr/>
        </p:nvCxnSpPr>
        <p:spPr>
          <a:xfrm flipH="1">
            <a:off x="6629400" y="3124200"/>
            <a:ext cx="76200" cy="14478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2709035" y="995665"/>
            <a:ext cx="2400016" cy="923330"/>
          </a:xfrm>
          <a:prstGeom prst="rect">
            <a:avLst/>
          </a:prstGeom>
          <a:solidFill>
            <a:schemeClr val="accent6"/>
          </a:solidFill>
        </p:spPr>
        <p:txBody>
          <a:bodyPr wrap="none" rtlCol="0">
            <a:spAutoFit/>
          </a:bodyPr>
          <a:lstStyle/>
          <a:p>
            <a:r>
              <a:rPr lang="en-US" dirty="0" smtClean="0"/>
              <a:t>5’ TATAGAATCTATA 3’  b</a:t>
            </a:r>
          </a:p>
          <a:p>
            <a:r>
              <a:rPr lang="en-US" dirty="0" smtClean="0"/>
              <a:t>                 x</a:t>
            </a:r>
          </a:p>
          <a:p>
            <a:r>
              <a:rPr lang="en-US" dirty="0" smtClean="0"/>
              <a:t>3’ ATATCTTAGATAT 5’   a</a:t>
            </a:r>
            <a:endParaRPr lang="en-US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3493641" y="1224265"/>
            <a:ext cx="200891" cy="23306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3777628" y="1531297"/>
            <a:ext cx="200335" cy="14793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2413761" y="4572000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2673356" y="458774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1752600" y="5867400"/>
            <a:ext cx="15460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tarting </a:t>
            </a:r>
            <a:r>
              <a:rPr lang="en-US" dirty="0" err="1" smtClean="0"/>
              <a:t>Oligos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5791200" y="5867400"/>
            <a:ext cx="19271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ug-DNA adducts</a:t>
            </a:r>
            <a:endParaRPr lang="en-US" dirty="0"/>
          </a:p>
        </p:txBody>
      </p:sp>
      <p:cxnSp>
        <p:nvCxnSpPr>
          <p:cNvPr id="8" name="Straight Arrow Connector 7"/>
          <p:cNvCxnSpPr>
            <a:stCxn id="2" idx="0"/>
          </p:cNvCxnSpPr>
          <p:nvPr/>
        </p:nvCxnSpPr>
        <p:spPr>
          <a:xfrm flipV="1">
            <a:off x="2525601" y="5257800"/>
            <a:ext cx="183434" cy="6096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 flipH="1" flipV="1">
            <a:off x="5029200" y="4756666"/>
            <a:ext cx="1371600" cy="111073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>
            <a:stCxn id="4" idx="0"/>
          </p:cNvCxnSpPr>
          <p:nvPr/>
        </p:nvCxnSpPr>
        <p:spPr>
          <a:xfrm flipV="1">
            <a:off x="6754766" y="4495800"/>
            <a:ext cx="712834" cy="13716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085437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228600"/>
            <a:ext cx="8531225" cy="5486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5325" y="232447"/>
            <a:ext cx="1676400" cy="36941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" name="Straight Arrow Connector 2"/>
          <p:cNvCxnSpPr/>
          <p:nvPr/>
        </p:nvCxnSpPr>
        <p:spPr>
          <a:xfrm flipH="1">
            <a:off x="5105400" y="3581400"/>
            <a:ext cx="381000" cy="2286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/>
          <p:cNvCxnSpPr/>
          <p:nvPr/>
        </p:nvCxnSpPr>
        <p:spPr>
          <a:xfrm flipH="1">
            <a:off x="6629400" y="3124200"/>
            <a:ext cx="76200" cy="14478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6858000" y="533400"/>
            <a:ext cx="304800" cy="8382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6858000" y="990600"/>
            <a:ext cx="609600" cy="2286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7467600" y="1219200"/>
            <a:ext cx="0" cy="2286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6858000" y="2209800"/>
            <a:ext cx="53340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2709035" y="995665"/>
            <a:ext cx="2400016" cy="923330"/>
          </a:xfrm>
          <a:prstGeom prst="rect">
            <a:avLst/>
          </a:prstGeom>
          <a:solidFill>
            <a:schemeClr val="accent6"/>
          </a:solidFill>
        </p:spPr>
        <p:txBody>
          <a:bodyPr wrap="none" rtlCol="0">
            <a:spAutoFit/>
          </a:bodyPr>
          <a:lstStyle/>
          <a:p>
            <a:r>
              <a:rPr lang="en-US" dirty="0" smtClean="0"/>
              <a:t>5’ TATAGAATCTATA 3’  b</a:t>
            </a:r>
          </a:p>
          <a:p>
            <a:r>
              <a:rPr lang="en-US" dirty="0" smtClean="0"/>
              <a:t>                 x</a:t>
            </a:r>
          </a:p>
          <a:p>
            <a:r>
              <a:rPr lang="en-US" dirty="0" smtClean="0"/>
              <a:t>3’ ATATCTTAGATAT 5’   a</a:t>
            </a:r>
            <a:endParaRPr lang="en-US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3493641" y="1224265"/>
            <a:ext cx="200891" cy="23306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3777628" y="1531297"/>
            <a:ext cx="200335" cy="14793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2413761" y="4572000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2673356" y="458774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1752600" y="5867400"/>
            <a:ext cx="15460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tarting </a:t>
            </a:r>
            <a:r>
              <a:rPr lang="en-US" dirty="0" err="1" smtClean="0"/>
              <a:t>Oligos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5791200" y="5867400"/>
            <a:ext cx="19271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ug-DNA adducts</a:t>
            </a:r>
            <a:endParaRPr lang="en-US" dirty="0"/>
          </a:p>
        </p:txBody>
      </p:sp>
      <p:cxnSp>
        <p:nvCxnSpPr>
          <p:cNvPr id="8" name="Straight Arrow Connector 7"/>
          <p:cNvCxnSpPr>
            <a:stCxn id="2" idx="0"/>
          </p:cNvCxnSpPr>
          <p:nvPr/>
        </p:nvCxnSpPr>
        <p:spPr>
          <a:xfrm flipV="1">
            <a:off x="2525601" y="5257800"/>
            <a:ext cx="183434" cy="6096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 flipH="1" flipV="1">
            <a:off x="5029200" y="4756666"/>
            <a:ext cx="1371600" cy="111073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>
            <a:stCxn id="4" idx="0"/>
          </p:cNvCxnSpPr>
          <p:nvPr/>
        </p:nvCxnSpPr>
        <p:spPr>
          <a:xfrm flipV="1">
            <a:off x="6754766" y="4495800"/>
            <a:ext cx="712834" cy="13716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5791200" y="533400"/>
            <a:ext cx="457200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5451501" y="471100"/>
            <a:ext cx="8819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 smtClean="0"/>
              <a:t>Monoamide</a:t>
            </a:r>
            <a:endParaRPr lang="en-US" sz="1100" dirty="0"/>
          </a:p>
        </p:txBody>
      </p:sp>
      <p:sp>
        <p:nvSpPr>
          <p:cNvPr id="12" name="Rectangle 11"/>
          <p:cNvSpPr/>
          <p:nvPr/>
        </p:nvSpPr>
        <p:spPr>
          <a:xfrm>
            <a:off x="5715000" y="1104900"/>
            <a:ext cx="533400" cy="1905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/>
          <p:cNvSpPr txBox="1"/>
          <p:nvPr/>
        </p:nvSpPr>
        <p:spPr>
          <a:xfrm>
            <a:off x="5486400" y="1037406"/>
            <a:ext cx="8819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Monoamine</a:t>
            </a:r>
            <a:endParaRPr lang="en-US" sz="1100" dirty="0"/>
          </a:p>
        </p:txBody>
      </p:sp>
      <p:sp>
        <p:nvSpPr>
          <p:cNvPr id="17" name="Rectangle 16"/>
          <p:cNvSpPr/>
          <p:nvPr/>
        </p:nvSpPr>
        <p:spPr>
          <a:xfrm>
            <a:off x="5754926" y="2286000"/>
            <a:ext cx="493474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/>
          <p:cNvSpPr txBox="1"/>
          <p:nvPr/>
        </p:nvSpPr>
        <p:spPr>
          <a:xfrm>
            <a:off x="5560676" y="2220372"/>
            <a:ext cx="7906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PBD dimer</a:t>
            </a:r>
            <a:endParaRPr lang="en-US" sz="1100" dirty="0"/>
          </a:p>
        </p:txBody>
      </p:sp>
      <p:sp>
        <p:nvSpPr>
          <p:cNvPr id="18" name="Rectangle 17"/>
          <p:cNvSpPr/>
          <p:nvPr/>
        </p:nvSpPr>
        <p:spPr>
          <a:xfrm>
            <a:off x="5145325" y="1340797"/>
            <a:ext cx="1712675" cy="5781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4975026" y="2504028"/>
            <a:ext cx="1959174" cy="80806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/>
          <p:cNvSpPr txBox="1"/>
          <p:nvPr/>
        </p:nvSpPr>
        <p:spPr>
          <a:xfrm>
            <a:off x="6128427" y="3006897"/>
            <a:ext cx="9829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Buffer control</a:t>
            </a:r>
            <a:endParaRPr lang="en-US" sz="1100" dirty="0"/>
          </a:p>
        </p:txBody>
      </p:sp>
      <p:sp>
        <p:nvSpPr>
          <p:cNvPr id="23" name="Rectangle 22"/>
          <p:cNvSpPr/>
          <p:nvPr/>
        </p:nvSpPr>
        <p:spPr>
          <a:xfrm>
            <a:off x="5715000" y="3780710"/>
            <a:ext cx="533400" cy="1816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/>
          <p:cNvSpPr txBox="1"/>
          <p:nvPr/>
        </p:nvSpPr>
        <p:spPr>
          <a:xfrm>
            <a:off x="5604638" y="3700790"/>
            <a:ext cx="10182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PBD monomer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37755839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48</Words>
  <Application>Microsoft Office PowerPoint</Application>
  <PresentationFormat>On-screen Show (4:3)</PresentationFormat>
  <Paragraphs>1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Genentech,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nglu Zhang</dc:creator>
  <cp:lastModifiedBy>Zhang, Donglu {GNMM~SOUTH SAN FRANCISCO}</cp:lastModifiedBy>
  <cp:revision>4</cp:revision>
  <dcterms:created xsi:type="dcterms:W3CDTF">2015-07-22T22:06:59Z</dcterms:created>
  <dcterms:modified xsi:type="dcterms:W3CDTF">2023-07-13T20:21:47Z</dcterms:modified>
</cp:coreProperties>
</file>